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214" autoAdjust="0"/>
  </p:normalViewPr>
  <p:slideViewPr>
    <p:cSldViewPr snapToGrid="0">
      <p:cViewPr varScale="1">
        <p:scale>
          <a:sx n="82" d="100"/>
          <a:sy n="82" d="100"/>
        </p:scale>
        <p:origin x="178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systemanalytic365.sharepoint.com/sites/SharepointFileStorage/Marketing%20%20PR/Thought%20Leader%20Pieces/03.%20Early%20Access%20Provision%202020/03.%20Deliverables/EAP%20Raw%20Data%2019.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7FCB-4DD1-BE7B-71C7D82C96E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644-4899-A031-A3E658466ED8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0644-4899-A031-A3E658466ED8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644-4899-A031-A3E658466ED8}"/>
              </c:ext>
            </c:extLst>
          </c:dPt>
          <c:cat>
            <c:strRef>
              <c:f>'[EAP Raw Data 19.02.xlsx]#13 challenges'!$B$2:$B$5</c:f>
              <c:strCache>
                <c:ptCount val="4"/>
                <c:pt idx="0">
                  <c:v>Time constrains  </c:v>
                </c:pt>
                <c:pt idx="1">
                  <c:v>Limited information available/provided  </c:v>
                </c:pt>
                <c:pt idx="2">
                  <c:v>Organizational (e.g. not clear on roles and responsibilities between manufacturer and treating physician)  </c:v>
                </c:pt>
                <c:pt idx="3">
                  <c:v>Financial  </c:v>
                </c:pt>
              </c:strCache>
            </c:strRef>
          </c:cat>
          <c:val>
            <c:numRef>
              <c:f>'[EAP Raw Data 19.02.xlsx]#13 challenges'!$C$2:$C$5</c:f>
              <c:numCache>
                <c:formatCode>0%</c:formatCode>
                <c:ptCount val="4"/>
                <c:pt idx="0" formatCode="0.00%">
                  <c:v>0.76700000000000002</c:v>
                </c:pt>
                <c:pt idx="1">
                  <c:v>0.43</c:v>
                </c:pt>
                <c:pt idx="2" formatCode="0.00%">
                  <c:v>0.46500000000000002</c:v>
                </c:pt>
                <c:pt idx="3" formatCode="0.00%">
                  <c:v>0.3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44-4899-A031-A3E658466E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42041632"/>
        <c:axId val="1142044544"/>
      </c:barChart>
      <c:catAx>
        <c:axId val="1142041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1142044544"/>
        <c:crosses val="autoZero"/>
        <c:auto val="1"/>
        <c:lblAlgn val="ctr"/>
        <c:lblOffset val="100"/>
        <c:noMultiLvlLbl val="0"/>
      </c:catAx>
      <c:valAx>
        <c:axId val="114204454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1142041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60FE9-566C-4D95-9304-401478008E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B49D3B-AFAE-4FCE-86E6-515C54191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0AB1A-BB09-4DC7-9DDA-04302E7CA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BCF127-C4DB-47AB-BABC-21651435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D5EEE-8411-4306-9019-EA284A8F4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45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4A676-CB94-4DDF-B349-59436C5E4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21B5BC-5FB7-460D-B6C3-97897F7645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F0FAD-8A9C-4797-9712-ADC028C0A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DA043F-45C6-402B-B8E0-B8D1240E2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84154-F9ED-41F8-A5C9-D1ED3044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382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6BDB66-BEA0-401C-BCA1-AF456A971E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237161-9F41-4DC9-B35F-EBC2C1279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6CB68E-250A-463A-AE06-4D42E146B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A8C4BF-BC95-40D3-95EA-0AB576787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6091E-421F-462F-84F1-33ECF01C0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966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8BC7D-AB0D-4AC7-8EAB-3F0570B71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7DAD68-F6CD-40CB-82D4-7A4B321CA0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74B1B-DABA-419C-8E1D-F3D7E08F6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06877-630B-4658-ADE7-DB4FDB981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F129F-E00E-46CC-8478-8D53C7973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314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A50A8-F3A6-4D3E-B313-DEF6A3E33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8C18B2-6DE4-48E7-8B96-BA8C85D0D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AD6B4-A94F-4CA4-8654-87F4C420E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FE9D5-EB32-4A51-97E3-82742131C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E3288-14D7-4252-8841-95697ACD3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387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263EE-0D6C-4DC3-A033-63FC2D204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646ADC-CF01-44D7-A32A-3072C858CB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E8946B-EA93-4292-A38C-70E4F6CE4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D3A1F2-89B8-40B9-9913-9E51C30A8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29439B-99D1-496F-BA97-A1A470C3C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852E6-4557-48B1-9344-A4176A518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292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7DF59-D8DB-42C7-9D6D-2324E6B5F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04F8E-912B-4644-AE6E-778AD09319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5C88E0-8A64-4157-9CCC-326B324E2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251E89-7B6C-4909-9013-52E8E27B99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9C570-FBD9-48AA-8844-03861D1947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6DF997-366A-4433-A0B3-3F4A70B0F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787223-6F68-4D82-99E5-9B93456BA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457904-6528-4962-8799-D344B9811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92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99DAA-8BB5-418A-8DD7-92FA9FAF01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9FB9E9-7F97-4014-AC6F-D5C409C02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6C7FF6-5BB4-491F-ABDB-F79F5567D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86CF20-280E-4CF1-8E34-BDCCC0FA9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69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D37C83-1465-40FA-B60C-5A757A629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49D5DF-A388-42DF-AAC6-50E873BAF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24C439-7602-4E6C-93D8-AB9C9AC95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4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AF85D-A3C7-40C0-AE79-2658B0501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D882E-166A-4741-8CAB-8B87F8601F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9B494D-1B4C-4B7C-81C2-ED69154AC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4E7A9F-92AF-4AA5-91D8-0D990E1CD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AD82ED-ABBD-4ECA-B66B-92A2A0102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2807BD-04BF-4C15-8702-78A0498A4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299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B39FC-52B2-43AF-BFD4-2BC6A5867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A64028-D7E6-40DE-9DB2-4C6B805434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A8C7E-5AD9-44E8-9FA9-0A142B11A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4AE9D-6A51-4461-8D4B-182B72DE9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0B7836-440A-479A-AA19-4F6F8F216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1617F-18C7-43B7-97CF-CD2D91726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8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21F483-1254-4497-A2AE-DD9D65EA8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CB1193-95B1-4422-AA91-D776F58B6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05CB6A-D727-4D63-A7E8-220E344123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C933E5-4CC0-41F1-B0D1-A9A2EBE7DB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BAEE3A-31CE-4B95-AC24-963217E53B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777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9B8FD-400E-4DFD-8145-03EA3B5C211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Supplementary Figures 3</a:t>
            </a:r>
            <a:br>
              <a:rPr lang="en-GB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86FBB7-219B-4ABD-9D79-46E73A98296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 lnSpcReduction="10000"/>
          </a:bodyPr>
          <a:lstStyle/>
          <a:p>
            <a:r>
              <a:rPr lang="en-GB" dirty="0"/>
              <a:t>Manuscript: Early Access Provision: Awareness, Educational Needs and Opportunities to Improve Oncology Patients’ Access to </a:t>
            </a:r>
            <a:r>
              <a:rPr lang="en-GB"/>
              <a:t>Care </a:t>
            </a:r>
          </a:p>
          <a:p>
            <a:endParaRPr lang="en-GB" dirty="0"/>
          </a:p>
          <a:p>
            <a:r>
              <a:rPr lang="en-GB" dirty="0" err="1"/>
              <a:t>A.Krendyukov</a:t>
            </a:r>
            <a:r>
              <a:rPr lang="en-GB" dirty="0"/>
              <a:t>, </a:t>
            </a:r>
            <a:r>
              <a:rPr lang="en-GB" dirty="0" err="1"/>
              <a:t>S.Singhvi</a:t>
            </a:r>
            <a:r>
              <a:rPr lang="en-GB" dirty="0"/>
              <a:t>, </a:t>
            </a:r>
            <a:r>
              <a:rPr lang="en-US" dirty="0" err="1"/>
              <a:t>Y.Green</a:t>
            </a:r>
            <a:r>
              <a:rPr lang="en-US" dirty="0"/>
              <a:t>-Morrison, </a:t>
            </a:r>
            <a:r>
              <a:rPr lang="en-US" dirty="0" err="1"/>
              <a:t>M.Zabransky</a:t>
            </a:r>
            <a:r>
              <a:rPr lang="en-US" b="1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1788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F7C561-CB59-4FA5-88A7-1E896809C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15133" y="298617"/>
            <a:ext cx="10515600" cy="763960"/>
          </a:xfrm>
          <a:noFill/>
        </p:spPr>
        <p:txBody>
          <a:bodyPr>
            <a:noAutofit/>
          </a:bodyPr>
          <a:lstStyle/>
          <a:p>
            <a:br>
              <a:rPr lang="en-US" sz="2800" b="0" i="0" u="none" strike="noStrike" baseline="0" dirty="0">
                <a:effectLst/>
              </a:rPr>
            </a:br>
            <a:br>
              <a:rPr lang="en-US" sz="2800" b="1" dirty="0"/>
            </a:br>
            <a:r>
              <a:rPr lang="en-US" sz="2800" dirty="0"/>
              <a:t>T</a:t>
            </a:r>
            <a:r>
              <a:rPr lang="en-US" sz="2400" i="0" u="none" strike="noStrike" baseline="0" dirty="0">
                <a:effectLst/>
              </a:rPr>
              <a:t>ypical and common challenges faced by practicing </a:t>
            </a:r>
            <a:r>
              <a:rPr lang="en-US" sz="2400" i="0" u="none" strike="noStrike" baseline="0" dirty="0" err="1">
                <a:effectLst/>
              </a:rPr>
              <a:t>phycisian</a:t>
            </a:r>
            <a:r>
              <a:rPr lang="en-US" sz="2400" i="0" u="none" strike="noStrike" baseline="0" dirty="0">
                <a:effectLst/>
              </a:rPr>
              <a:t> when dealing with early access provision in daily</a:t>
            </a:r>
            <a:r>
              <a:rPr lang="en-US" sz="2400" i="0" u="none" strike="noStrike" dirty="0">
                <a:effectLst/>
              </a:rPr>
              <a:t> activities</a:t>
            </a:r>
            <a:br>
              <a:rPr lang="en-US" sz="2400" i="0" u="none" strike="noStrike" baseline="0" dirty="0">
                <a:effectLst/>
              </a:rPr>
            </a:br>
            <a:br>
              <a:rPr lang="en-US" sz="2800" dirty="0"/>
            </a:br>
            <a:endParaRPr lang="en-US" sz="2800" dirty="0"/>
          </a:p>
        </p:txBody>
      </p:sp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2B811A01-D1CE-4ED3-94BF-FD1FF1FDEF0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25324901"/>
              </p:ext>
            </p:extLst>
          </p:nvPr>
        </p:nvGraphicFramePr>
        <p:xfrm>
          <a:off x="393405" y="1650840"/>
          <a:ext cx="11493795" cy="5122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48347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00FF81"/>
      </a:accent1>
      <a:accent2>
        <a:srgbClr val="08CFEE"/>
      </a:accent2>
      <a:accent3>
        <a:srgbClr val="FFEC00"/>
      </a:accent3>
      <a:accent4>
        <a:srgbClr val="FB90FF"/>
      </a:accent4>
      <a:accent5>
        <a:srgbClr val="FF8300"/>
      </a:accent5>
      <a:accent6>
        <a:srgbClr val="73FBFF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0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ry Figures 3 </vt:lpstr>
      <vt:lpstr>  Typical and common challenges faced by practicing phycisian when dealing with early access provision in daily activities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aphs for EAP</dc:title>
  <dc:creator>Yianick Green-Morrison</dc:creator>
  <cp:lastModifiedBy>Andriy Andriy</cp:lastModifiedBy>
  <cp:revision>21</cp:revision>
  <dcterms:created xsi:type="dcterms:W3CDTF">2021-05-14T10:53:58Z</dcterms:created>
  <dcterms:modified xsi:type="dcterms:W3CDTF">2022-10-21T08:45:48Z</dcterms:modified>
</cp:coreProperties>
</file>